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media/image9.wmf" ContentType="image/x-wmf"/>
  <Override PartName="/ppt/media/image14.wmf" ContentType="image/x-wmf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10.wmf" ContentType="image/x-wmf"/>
  <Override PartName="/ppt/media/image6.wmf" ContentType="image/x-wmf"/>
  <Override PartName="/ppt/media/image11.wmf" ContentType="image/x-wmf"/>
  <Override PartName="/ppt/media/image7.wmf" ContentType="image/x-wmf"/>
  <Override PartName="/ppt/media/image12.wmf" ContentType="image/x-wmf"/>
  <Override PartName="/ppt/media/image8.wmf" ContentType="image/x-wmf"/>
  <Override PartName="/ppt/media/image13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2573EF-CAD0-418E-8ABC-9DBF8287E60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6A3699-208E-4F88-9005-DA8C7CAD6A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670250-0028-457D-84BD-5547CBDC1BC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A12278-9A36-4328-923E-FA085855F99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03C5F9-97F4-40D5-AFC6-702F8C0A9D1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AECFBB-AEF0-4068-BB4C-5FDC55A95B4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8B84CF-D446-4F67-96BD-2FE2F522E45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7D2533-69D8-4E25-90EB-949D3DF937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514CF9-10DB-4E3F-B634-CD2FC5AAC79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9C8B63-E662-46D8-8267-3D83E3F6E0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9D0F79-5848-4A5B-8E51-5E1F8721FB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F076D4-215D-4F37-B5A0-119BC87616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B9842DD-09D6-4F1B-BD21-2B90C2FFB97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.wmf"/><Relationship Id="rId5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3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5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6.wmf"/><Relationship Id="rId5" Type="http://schemas.openxmlformats.org/officeDocument/2006/relationships/slideLayout" Target="../slideLayouts/slideLayout2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7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8.wmf"/><Relationship Id="rId5" Type="http://schemas.openxmlformats.org/officeDocument/2006/relationships/slideLayout" Target="../slideLayouts/slideLayout2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9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10.wmf"/><Relationship Id="rId5" Type="http://schemas.openxmlformats.org/officeDocument/2006/relationships/slideLayout" Target="../slideLayouts/slideLayout2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12.wmf"/><Relationship Id="rId5" Type="http://schemas.openxmlformats.org/officeDocument/2006/relationships/slideLayout" Target="../slideLayouts/slideLayout2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3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14.wmf"/><Relationship Id="rId5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04640" y="250920"/>
            <a:ext cx="6193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Additional File 2: Linear range of ERCC detection (A) microarray (B) RT-qPCR platforms: ERCC-4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1052640" y="1042920"/>
          <a:ext cx="4705200" cy="382896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3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052640" y="1042920"/>
                    <a:ext cx="4705200" cy="3828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4" name=""/>
          <p:cNvGraphicFramePr/>
          <p:nvPr/>
        </p:nvGraphicFramePr>
        <p:xfrm>
          <a:off x="1204920" y="5076720"/>
          <a:ext cx="4448160" cy="377208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45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204920" y="5076720"/>
                    <a:ext cx="4448160" cy="3772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6" name=""/>
          <p:cNvSpPr/>
          <p:nvPr/>
        </p:nvSpPr>
        <p:spPr>
          <a:xfrm>
            <a:off x="5516640" y="971640"/>
            <a:ext cx="57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5445000" y="5219640"/>
            <a:ext cx="57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"/>
          <p:cNvSpPr/>
          <p:nvPr/>
        </p:nvSpPr>
        <p:spPr>
          <a:xfrm>
            <a:off x="404640" y="250920"/>
            <a:ext cx="6193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Additional File 2: Linear range of ERCC detection (A) microarray (B) RT-qPCR platforms: ERCC-8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9" name=""/>
          <p:cNvGraphicFramePr/>
          <p:nvPr/>
        </p:nvGraphicFramePr>
        <p:xfrm>
          <a:off x="1197000" y="1116000"/>
          <a:ext cx="4438800" cy="382896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50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197000" y="1116000"/>
                    <a:ext cx="4438800" cy="3828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1" name=""/>
          <p:cNvGraphicFramePr/>
          <p:nvPr/>
        </p:nvGraphicFramePr>
        <p:xfrm>
          <a:off x="1197000" y="4859280"/>
          <a:ext cx="4448160" cy="402912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52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197000" y="4859280"/>
                    <a:ext cx="4448160" cy="4029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3" name=""/>
          <p:cNvSpPr/>
          <p:nvPr/>
        </p:nvSpPr>
        <p:spPr>
          <a:xfrm>
            <a:off x="5445000" y="1042920"/>
            <a:ext cx="57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5445000" y="4932360"/>
            <a:ext cx="57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"/>
          <p:cNvSpPr/>
          <p:nvPr/>
        </p:nvSpPr>
        <p:spPr>
          <a:xfrm>
            <a:off x="404640" y="250920"/>
            <a:ext cx="6193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Additional File 2: Linear range of ERCC detection (A) microarray (B) RT-qPCR platforms: ERCC-8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6" name=""/>
          <p:cNvGraphicFramePr/>
          <p:nvPr/>
        </p:nvGraphicFramePr>
        <p:xfrm>
          <a:off x="1197000" y="1042920"/>
          <a:ext cx="4448160" cy="379116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57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197000" y="1042920"/>
                    <a:ext cx="4448160" cy="3791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8" name=""/>
          <p:cNvGraphicFramePr/>
          <p:nvPr/>
        </p:nvGraphicFramePr>
        <p:xfrm>
          <a:off x="1197000" y="5086440"/>
          <a:ext cx="4467240" cy="405756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59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197000" y="5086440"/>
                    <a:ext cx="4467240" cy="4057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0" name=""/>
          <p:cNvSpPr/>
          <p:nvPr/>
        </p:nvSpPr>
        <p:spPr>
          <a:xfrm>
            <a:off x="5445000" y="971640"/>
            <a:ext cx="57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5445000" y="5148360"/>
            <a:ext cx="57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"/>
          <p:cNvSpPr/>
          <p:nvPr/>
        </p:nvSpPr>
        <p:spPr>
          <a:xfrm>
            <a:off x="404640" y="250920"/>
            <a:ext cx="6193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Additional File 2: Linear range of ERCC detection (A) microarray (B) RT-qPCR platforms: ERCC-9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3" name=""/>
          <p:cNvGraphicFramePr/>
          <p:nvPr/>
        </p:nvGraphicFramePr>
        <p:xfrm>
          <a:off x="1197000" y="1187280"/>
          <a:ext cx="4429080" cy="375300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64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197000" y="1187280"/>
                    <a:ext cx="4429080" cy="3753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5" name=""/>
          <p:cNvGraphicFramePr/>
          <p:nvPr/>
        </p:nvGraphicFramePr>
        <p:xfrm>
          <a:off x="1268280" y="4932360"/>
          <a:ext cx="4476960" cy="405756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66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268280" y="4932360"/>
                    <a:ext cx="4476960" cy="4057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7" name=""/>
          <p:cNvSpPr/>
          <p:nvPr/>
        </p:nvSpPr>
        <p:spPr>
          <a:xfrm>
            <a:off x="5445000" y="1116000"/>
            <a:ext cx="57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5516640" y="4997520"/>
            <a:ext cx="57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"/>
          <p:cNvSpPr/>
          <p:nvPr/>
        </p:nvSpPr>
        <p:spPr>
          <a:xfrm>
            <a:off x="404640" y="250920"/>
            <a:ext cx="6193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Additional File 2: Linear range of ERCC detection (A) microarray (B) RT-qPCR platforms: ERCC-9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0" name=""/>
          <p:cNvGraphicFramePr/>
          <p:nvPr/>
        </p:nvGraphicFramePr>
        <p:xfrm>
          <a:off x="1197000" y="1187280"/>
          <a:ext cx="4448160" cy="377208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71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197000" y="1187280"/>
                    <a:ext cx="4448160" cy="3772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2" name=""/>
          <p:cNvGraphicFramePr/>
          <p:nvPr/>
        </p:nvGraphicFramePr>
        <p:xfrm>
          <a:off x="1181160" y="5060880"/>
          <a:ext cx="4495680" cy="404820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73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181160" y="5060880"/>
                    <a:ext cx="4495680" cy="4048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4" name=""/>
          <p:cNvSpPr/>
          <p:nvPr/>
        </p:nvSpPr>
        <p:spPr>
          <a:xfrm>
            <a:off x="5445000" y="1116000"/>
            <a:ext cx="57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5445000" y="5003640"/>
            <a:ext cx="57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"/>
          <p:cNvSpPr/>
          <p:nvPr/>
        </p:nvSpPr>
        <p:spPr>
          <a:xfrm>
            <a:off x="404640" y="250920"/>
            <a:ext cx="6193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Additional File 2: Linear range of ERCC detection (A) microarray (B) RT-qPCR platforms: ERCC-11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7" name=""/>
          <p:cNvGraphicFramePr/>
          <p:nvPr/>
        </p:nvGraphicFramePr>
        <p:xfrm>
          <a:off x="1125360" y="1042920"/>
          <a:ext cx="4448520" cy="378144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78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125360" y="1042920"/>
                    <a:ext cx="4448520" cy="3781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9" name=""/>
          <p:cNvGraphicFramePr/>
          <p:nvPr/>
        </p:nvGraphicFramePr>
        <p:xfrm>
          <a:off x="1125360" y="4859280"/>
          <a:ext cx="4505400" cy="406728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80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125360" y="4859280"/>
                    <a:ext cx="4505400" cy="4067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1" name=""/>
          <p:cNvSpPr/>
          <p:nvPr/>
        </p:nvSpPr>
        <p:spPr>
          <a:xfrm>
            <a:off x="5373720" y="965160"/>
            <a:ext cx="57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5445000" y="4859280"/>
            <a:ext cx="57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"/>
          <p:cNvSpPr/>
          <p:nvPr/>
        </p:nvSpPr>
        <p:spPr>
          <a:xfrm>
            <a:off x="404640" y="250920"/>
            <a:ext cx="6193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Additional File 2: Linear range of ERCC detection (A) microarray (B) RT-qPCR platforms: ERCC-17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84" name=""/>
          <p:cNvGraphicFramePr/>
          <p:nvPr/>
        </p:nvGraphicFramePr>
        <p:xfrm>
          <a:off x="1197000" y="1187280"/>
          <a:ext cx="4457520" cy="378144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85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197000" y="1187280"/>
                    <a:ext cx="4457520" cy="3781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86" name=""/>
          <p:cNvGraphicFramePr/>
          <p:nvPr/>
        </p:nvGraphicFramePr>
        <p:xfrm>
          <a:off x="1171440" y="5041800"/>
          <a:ext cx="4515120" cy="406728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87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171440" y="5041800"/>
                    <a:ext cx="4515120" cy="4067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8" name=""/>
          <p:cNvSpPr/>
          <p:nvPr/>
        </p:nvSpPr>
        <p:spPr>
          <a:xfrm>
            <a:off x="5445000" y="1042920"/>
            <a:ext cx="57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5445000" y="4932360"/>
            <a:ext cx="57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3-11T09:01:24Z</dcterms:created>
  <dc:creator>Alison Devonshire</dc:creator>
  <dc:description/>
  <dc:language>en-US</dc:language>
  <cp:lastModifiedBy>Susan Pang</cp:lastModifiedBy>
  <dcterms:modified xsi:type="dcterms:W3CDTF">2010-05-06T12:51:58Z</dcterms:modified>
  <cp:revision>5</cp:revision>
  <dc:subject/>
  <dc:title>Slide 1</dc:title>
</cp:coreProperties>
</file>